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tr-T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48F48A-9928-47DD-95D2-44079B314EE2}" type="slidenum">
              <a:rPr b="0" lang="tr-T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tr-TR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E82461-3114-4650-B824-1940FCD80CA6}" type="slidenum">
              <a:rPr b="0" lang="tr-T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F2DE1-BDB1-4EF2-AB1A-76F096C776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DD7270-E0C7-403E-AAE1-16AA71E598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803C72-7F1E-4A1A-984A-E9D5F17DEE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6CFEE-D8AE-4B9A-A7D3-F0E31B78B4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9C266-1364-40AC-8CD4-D4170551F5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2E79F-A5FF-49E4-A46B-1585CEAC80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589D4A-EF2D-4F60-BED9-C1BBC25770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2DCD2-1C2F-41B1-AF93-3A421A0CEA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F39C9C-2976-422D-AFAE-DCB598E018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5A833D-8FBF-4D76-A1A8-79BF2A33F8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72E92-2BE1-4F62-9D0E-A9DDE4107C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A7A12-B795-4666-8DED-A9596E8E0B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tr-T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02A45E-7353-4480-AEE2-86DBCB1F2D4A}" type="slidenum">
              <a:rPr b="0" lang="tr-T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2"/>
          <p:cNvGraphicFramePr/>
          <p:nvPr/>
        </p:nvGraphicFramePr>
        <p:xfrm>
          <a:off x="0" y="907920"/>
          <a:ext cx="9144000" cy="5400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907920"/>
                    <a:ext cx="9144000" cy="5400720"/>
                  </a:xfrm>
                  <a:prstGeom prst="rect">
                    <a:avLst/>
                  </a:prstGeom>
                  <a:ln w="19080">
                    <a:solidFill>
                      <a:srgbClr val="333399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50" name="TextBox 2"/>
          <p:cNvSpPr/>
          <p:nvPr/>
        </p:nvSpPr>
        <p:spPr>
          <a:xfrm>
            <a:off x="250920" y="333360"/>
            <a:ext cx="8748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1600" spc="-1" strike="noStrike">
                <a:solidFill>
                  <a:srgbClr val="000000"/>
                </a:solidFill>
                <a:latin typeface="Comic Sans MS"/>
              </a:rPr>
              <a:t>Figure S 1. Distribution of the cities selected for sample for the Helicobacter pylori prevalance study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05T20:59:23Z</dcterms:created>
  <dc:creator>PC1109283</dc:creator>
  <dc:description/>
  <dc:language>en-US</dc:language>
  <cp:lastModifiedBy>nilüfer</cp:lastModifiedBy>
  <dcterms:modified xsi:type="dcterms:W3CDTF">2013-11-24T18:42:23Z</dcterms:modified>
  <cp:revision>36</cp:revision>
  <dc:subject/>
  <dc:title>Slide 1</dc:title>
</cp:coreProperties>
</file>